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73" r:id="rId2"/>
    <p:sldId id="263" r:id="rId3"/>
    <p:sldId id="266" r:id="rId4"/>
    <p:sldId id="262" r:id="rId5"/>
    <p:sldId id="257" r:id="rId6"/>
    <p:sldId id="258" r:id="rId7"/>
    <p:sldId id="260" r:id="rId8"/>
    <p:sldId id="259" r:id="rId9"/>
    <p:sldId id="261" r:id="rId10"/>
    <p:sldId id="270" r:id="rId11"/>
    <p:sldId id="271" r:id="rId12"/>
    <p:sldId id="272" r:id="rId13"/>
    <p:sldId id="264" r:id="rId14"/>
    <p:sldId id="265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ereira, Suzette L" initials="PSL" lastIdx="4" clrIdx="0">
    <p:extLst>
      <p:ext uri="{19B8F6BF-5375-455C-9EA6-DF929625EA0E}">
        <p15:presenceInfo xmlns:p15="http://schemas.microsoft.com/office/powerpoint/2012/main" userId="S::suzette.pereira@abbott.com::a2d75052-04b1-4146-a885-8d1d05d63eba" providerId="AD"/>
      </p:ext>
    </p:extLst>
  </p:cmAuthor>
  <p:cmAuthor id="2" name="Prado, Carla" initials="PC" lastIdx="3" clrIdx="1">
    <p:extLst>
      <p:ext uri="{19B8F6BF-5375-455C-9EA6-DF929625EA0E}">
        <p15:presenceInfo xmlns:p15="http://schemas.microsoft.com/office/powerpoint/2012/main" userId="S::carla.prado@ales.ualberta.ca::1f351f95-25ad-4145-b34d-944af04bdc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97" autoAdjust="0"/>
    <p:restoredTop sz="84841" autoAdjust="0"/>
  </p:normalViewPr>
  <p:slideViewPr>
    <p:cSldViewPr snapToGrid="0" showGuides="1">
      <p:cViewPr>
        <p:scale>
          <a:sx n="100" d="100"/>
          <a:sy n="100" d="100"/>
        </p:scale>
        <p:origin x="852" y="66"/>
      </p:cViewPr>
      <p:guideLst>
        <p:guide orient="horz" pos="365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C18961-18E5-47E4-9942-56A1CC9D016D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A52F5D-8765-45F1-B5FF-80BD3DF45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5813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indent="450215" algn="l">
              <a:lnSpc>
                <a:spcPct val="200000"/>
              </a:lnSpc>
            </a:pPr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 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ffect direction plot summarizing direction of health impacts from studies administering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HMB) supplements in patients with cancer. Effect direction: upward arrow ▲= beneficial health impact, downward arrow ▼= no beneficial health impact, sideways arrow ◄►= mixed effects. Sample size: Final sample size (individuals) in intervention group as large arrow ▲ &gt;50; medium arrow ▲ 20-50; small arrow ▲ &lt;20. Study quality: denoted by row colour: green = low risk of bias; amber = some concerns; red = high risk of bias. Type of statistical test: A = change from baseline to follow-up within the experimental (i.e., intervention) arm; B = difference in change between experimental and control groups; C = difference between experimental and control groups at follow-up in controlled studies, and difference between baseline to follow-up within the experimental group in uncontrolled studies. * May et al. 2002 and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athmacher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t al. 2004 described findings from the same study. 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bbreviations: Arg, arginine; Gln, glutamine; HMB,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QofL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health-related quality of life; ONS, oral nutritional supplement; RCT, Randomised Controlled Trial.</a:t>
            </a:r>
          </a:p>
          <a:p>
            <a:b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3358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10 </a:t>
            </a:r>
            <a:r>
              <a:rPr lang="en-US" dirty="0"/>
              <a:t>Changes in protein intake from baseline to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ollow-up within experimental (green bar) and control (gray bar) groups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resent testing of differences between experimental and control groups. </a:t>
            </a:r>
            <a:r>
              <a:rPr lang="en-CA" sz="12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Δ* indicates absolute or percent mean change, and Δ† represents absolute median change.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40942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/>
              <a:t>Figure S11 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lormap depicting the number of studies reporting the effects of β-hydroxy β-</a:t>
            </a:r>
            <a:r>
              <a:rPr lang="en-CA" sz="1800" b="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ylbutyrate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HMB) supplementation on muscle mass and quality of life according to changes in total energy and protein intakes, adherence to the intervention protocol, and presence of nutrition co-intervention (i.e., routine nutritional care). Effect direction: upward arrow ▲= beneficial effect, downward arrow ▼= no beneficial effect.</a:t>
            </a:r>
            <a:endParaRPr lang="en-CA" sz="1800" b="1" kern="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42266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11 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isk of bias assessment of randomized controlled trials, stratified by study, outcomes, and domains. D1: Bias arising from the randomization process; D2: Bias due to deviations from intended intervention; D3: Bias due to missing outcome data; D4: Bias in measurement of the outcome; D5: Bias in selection of the reported result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77848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12 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isk of bias assessment of non-randomized studies of intervention, stratified by study, outcomes, and domains. D1: Bias due to confounding; D2: Bias due to selection of participants; D3: Bias in classification of interventions; D4: Bias due to deviations from intended interventions; D5: Bias due to missing data; D6: Bias in measurement of outcomes; D7: Bias in selection of the reported result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8960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lvl="0" indent="0" algn="just">
              <a:lnSpc>
                <a:spcPct val="200000"/>
              </a:lnSpc>
              <a:buFont typeface="+mj-lt"/>
              <a:buNone/>
            </a:pPr>
            <a:r>
              <a:rPr lang="en-CA" sz="18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Changes in muscle mass parameters from baseline to follow-up within experimental (green bar) and control (gray bar) groups. Δ* indicates absolute or percent mean change, and Δ† represents absolute or percent median change. </a:t>
            </a:r>
            <a:r>
              <a:rPr lang="en-CA" sz="1800" b="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alues reported in black correspond to testing of changes from baseline to follow-up. </a:t>
            </a:r>
            <a:r>
              <a:rPr lang="en-CA" sz="1800" b="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values reported in blue and positioned on the right side of figure represent testing of differences between experimental and control groups. Abbreviations: Arg, arginine; BIA, bioelectrical impedance analysis; CT, computed tomography; FFM, fat-free mass; Gln, glutamine; HMB, </a:t>
            </a:r>
            <a:r>
              <a:rPr lang="en-CA" sz="1800" b="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hydroxy </a:t>
            </a:r>
            <a:r>
              <a:rPr lang="en-CA" sz="1800" b="0" i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CA" sz="1800" b="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ylbutyrate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NR, not reported; NS, not significant; ONS, oral nutritional supplement; ↓</a:t>
            </a:r>
            <a:r>
              <a:rPr lang="en-CA" sz="1800" b="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oB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low risk of bias; ↔ </a:t>
            </a:r>
            <a:r>
              <a:rPr lang="en-CA" sz="1800" b="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oB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oderate risk of bias; ↑ </a:t>
            </a:r>
            <a:r>
              <a:rPr lang="en-CA" sz="1800" b="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oB</a:t>
            </a:r>
            <a:r>
              <a:rPr lang="en-CA" sz="18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igh risk of bias.</a:t>
            </a:r>
            <a:endParaRPr lang="en-CA" sz="1800" b="1" kern="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br>
              <a:rPr lang="en-CA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1182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3 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hanges in quality of life scores from baseline to follow-up within experimental (green bar) and control (gray bar) groups. Δ* indicates absolute or percent mean change, and Δ† represents absolute or percent median change.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ack correspond to testing of changes from baseline to follow-up.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ue represent testing of differences between experimental and control groups. Abbreviations: Arg, arginine; Gln, glutamine; HMB,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02352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4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hanges in measures of muscle function from baseline to follow-up within experimental (green bar) and control (gray bar) groups. Δ* indicates absolute or percent mean change, and Δ† represents absolute or percent median change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ack correspond to testing of changes from baseline to follow-up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ue represent testing of differences between experimental and control groups. 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64136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5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hanges in measures of body weight and body mass index (BMI) from baseline to follow-up within experimental (green bar) and control (gray bar) groups. Δ* indicates absolute or percent mean change, and Δ† represents absolute or percent median change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ack correspond to testing of changes from baseline to follow-up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orted in blue represent testing of differences between experimental and control groups. 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NR, not reported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16154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6 </a:t>
            </a:r>
            <a:r>
              <a:rPr lang="en-CA" sz="1200" dirty="0">
                <a:effectLst/>
                <a:latin typeface="Times New Roman" panose="02020603050405020304" pitchFamily="18" charset="0"/>
                <a:cs typeface="Arial" panose="020B0604020202020204" pitchFamily="34" charset="0"/>
              </a:rPr>
              <a:t>Incidence (in percent)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f cancer therapy-related toxicities at follow-up within experimental (green bar) and control (gray bar) groups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resent testing of differences between experimental and control groups. 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57366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7 </a:t>
            </a:r>
            <a:r>
              <a:rPr lang="en-US" dirty="0"/>
              <a:t>Hospital length of stay and rate of readmissions and complications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t follow-up within experimental (green bar) and control (gray bar) groups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resent testing of differences between experimental and control groups. 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83899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8 </a:t>
            </a:r>
            <a:r>
              <a:rPr lang="en-US" dirty="0"/>
              <a:t>Mortality and survival rates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t follow-up within experimental (green bar) and control (gray bar) groups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resent testing of differences between experimental and control groups. Studies with data not shown reported zero deaths during the period described in the graph.   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02133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Figure S9 </a:t>
            </a:r>
            <a:r>
              <a:rPr lang="en-US" dirty="0"/>
              <a:t>Changes in energy intake from baseline to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ollow-up within experimental (green bar) and control (gray bar) groups.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values represent testing of differences between experimental and control groups. </a:t>
            </a:r>
            <a:r>
              <a:rPr lang="en-CA" sz="1200" b="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Δ* indicates absolute or percent mean change, and Δ† represents absolute median change. 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bbreviations: Arg, arginine; Gln, glutamine; HMB,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ydroxy </a:t>
            </a:r>
            <a:r>
              <a:rPr lang="en-CA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en-CA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ethylbutyrate</a:t>
            </a:r>
            <a:r>
              <a:rPr lang="en-CA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ONS, oral nutritional supplement; 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↓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low risk of bias; ↔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moderate risk of bias; ↑ </a:t>
            </a:r>
            <a:r>
              <a:rPr lang="en-CA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B</a:t>
            </a:r>
            <a:r>
              <a:rPr lang="en-CA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high risk of bias.</a:t>
            </a:r>
            <a:endParaRPr lang="en-CA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A52F5D-8765-45F1-B5FF-80BD3DF45F3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6312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9744B9-876B-476F-BA5B-A80E0F4070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0A0F41-D344-4355-9B34-5ABC28E4EF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342FF6-57AA-492D-B3FB-FAF17719C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788658-7531-4BD9-8533-AC1F23A20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992214-BF24-4C90-B3CC-300018BCD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373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3E58F8-6058-4D2B-BAA5-F8FBC379E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9709F6-1666-4F31-BED2-B4D56F50F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0B2B3-1E49-4070-9D8B-E6B42FB085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6B1BB6-21D5-40D4-B184-A71DB66579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AB4F30-155D-40E3-835C-461CFDAF5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847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605402-547F-4FCF-939F-6CC847CEF6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51B897-8D3F-49F2-A1C4-6F9E3DA645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601E93-1F80-4B0E-985D-8418509DB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AA3F6D-9CBD-4E59-B25B-E3A7539A89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5B7FDC-5326-4A91-AACA-267A299546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832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DEF81F-8A54-4299-A582-D198F20879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4272B-9583-48B8-89D0-3A6075A364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20C0CE-F3F8-4056-ADFD-B64550C61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A0F3C-25FC-4EC1-9E6A-535D574CD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35FA0-573F-43FF-8768-DDE7EED3B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833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CB6821-91AC-468A-9ED4-52D7966D47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112ADB-D4B9-4074-99C3-6975C84725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9B1C90-4AFC-46E7-A6E0-304EC4DC3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109753-60E7-4F43-A666-A7088256E8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873993-7C43-4C00-A3B1-0E45163516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538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6771FF-7068-4A6C-8BBE-AA67CA8602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A92719-7932-49F6-A19A-D16843093B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454421-1E46-499B-8256-BA09677BF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E424F9-F0D4-457F-B839-9FF98FDF6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66048E-5FDA-4480-9CE2-C97FDC9D2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43D4F3-9770-4866-BA2C-5557F3985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75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DA56E7-7069-4187-841D-CD9F491125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74BDB0-C3B7-4F1A-95C9-F9CD63962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56A261-4BA6-480D-8BFF-9A10F4BF2F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66725A-6545-41EE-91DC-BA82834DF8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E083BB-7718-4691-8A9B-05EE9E1E2F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D66A89-4280-49D9-B212-8BDDED575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C312D78-1BF3-466C-BE3A-E527132AF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9744D15-AED3-4497-8C56-EC8B16FAD4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815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55F0F-17D8-42AB-BCAC-B63590C4E7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FF7FAC-37F0-4973-994B-A82C1D6D5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B01263-4A03-428C-9D82-C772D07B8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CE06B7-8AB7-4DA2-B359-2D699AE2C8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592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91F9BC-439E-4331-91B7-9F2CE2F8B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4A87B3-CC7A-4F6B-B868-2872B39D1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607C76-F44E-4F98-A511-CF4FE6C9B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3857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B9469-E9D3-41E9-9589-F3F8718ED4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73265B-27F0-4C01-BDDF-610C646EA5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36A29A-EAEA-428A-BB53-A3A0D953CC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3491C3-6A69-4AE3-B9A8-99CA16B27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01C0C8-26F6-4FF5-AF9A-FC46F3D05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02B1F1-1093-4C32-BD13-E1AD5C69A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917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6BA44-0E4E-4043-AA16-D85D12666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73B2D5-B142-43D9-AE1A-0B2D4EFB6E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CB638E2-CB96-4448-A4F1-D6797B7394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544E14-B93F-4FF5-96FA-AA0E0CC8E7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27BC20-60CA-4787-B7C9-38BF88816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580852-2887-44F7-B706-CB2B1C67A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314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9959D2-39C8-4D03-960E-89DF43FA0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245B08-CD59-4001-B4B3-111DD54AA4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2C70CC-5FF3-4620-A6FB-2B711BB52F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DA0CF-06E8-4350-AFFC-D8F8C0727281}" type="datetimeFigureOut">
              <a:rPr lang="en-US" smtClean="0"/>
              <a:t>2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22BBC-E906-4D08-8B35-96756E423F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41DB98-4F89-46EC-A22D-1E3438DFF4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B24BF-5A3D-4B38-BD52-1E5095A42B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785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sv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sv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sv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6.sv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sv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sv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svg"/><Relationship Id="rId5" Type="http://schemas.openxmlformats.org/officeDocument/2006/relationships/image" Target="../media/image15.png"/><Relationship Id="rId4" Type="http://schemas.openxmlformats.org/officeDocument/2006/relationships/image" Target="../media/image14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D6A93C4-2AE6-43B5-BBBD-4B7B6F0FC151}"/>
              </a:ext>
            </a:extLst>
          </p:cNvPr>
          <p:cNvSpPr txBox="1"/>
          <p:nvPr/>
        </p:nvSpPr>
        <p:spPr>
          <a:xfrm>
            <a:off x="358849" y="625156"/>
            <a:ext cx="11474302" cy="56076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s of 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hydroxy </a:t>
            </a:r>
            <a:r>
              <a:rPr lang="en-US" sz="16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6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ylbutyrate</a:t>
            </a: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HMB) supplementation on muscle mass, function, and other outcomes in patients with cancer: a systematic review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15000"/>
              </a:lnSpc>
            </a:pPr>
            <a:r>
              <a: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la M. Prado</a:t>
            </a:r>
            <a:r>
              <a:rPr lang="pt-BR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*</a:t>
            </a:r>
            <a:r>
              <a: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amila E. Orsso</a:t>
            </a:r>
            <a:r>
              <a:rPr lang="pt-BR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uzette L. Pereira</a:t>
            </a:r>
            <a:r>
              <a:rPr lang="pt-BR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Philip J. Atherton</a:t>
            </a:r>
            <a:r>
              <a:rPr lang="pt-BR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pt-BR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Nicolaas E. P. Deutz</a:t>
            </a:r>
            <a:r>
              <a:rPr lang="pt-BR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pt-BR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uman Nutrition Research Unit, Department of Agricultural, Food and Nutritional Science, University of Alberta, Canad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CA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CA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earch and Development, Abbott Nutrition, United States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</a:pPr>
            <a:r>
              <a:rPr lang="en-CA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</a:t>
            </a:r>
            <a:r>
              <a:rPr lang="en-CA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re of Metabolism, Ageing &amp; Physiology (COMAP), Medical Research Council (MRC) Versus Arthritis Centre for Musculoskeletal  Ageing Research (CMAR) and National Institution for Health Research (NIHR) Biomedical Research Centre (BRC), University of Nottingham, United Kingdom</a:t>
            </a:r>
          </a:p>
          <a:p>
            <a:pPr algn="just">
              <a:lnSpc>
                <a:spcPct val="115000"/>
              </a:lnSpc>
            </a:pPr>
            <a:r>
              <a:rPr lang="en-CA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CA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er for Translational Research in Aging &amp; Longevity, Department of Health &amp; Kinesiology, Texas A&amp;M University, United States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6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ing author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CA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fessor Carla M. Prado, PhD, RD</a:t>
            </a:r>
          </a:p>
          <a:p>
            <a:pPr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-021 Li Ka Shing Centre for Health Innovation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y of Alberta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monton, AB, Canada T6G 2E1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</a:pP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l: 780.492.7934 / Fax: 780.492.9555</a:t>
            </a:r>
            <a:endParaRPr lang="en-CA" sz="16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Email: Carla.prado@ualberta.ca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8272598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6950BCC4-D72C-47A0-A7F6-A334F9D043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57462" y="1509712"/>
            <a:ext cx="7077075" cy="38385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7C5B4C-F2FE-4B6D-A7EB-48B7CD7FAB6E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9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46895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6579BD5A-09C1-4643-9519-EFD4F3B1F1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371725" y="1690687"/>
            <a:ext cx="7448550" cy="34766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4E34B20-87D8-4AD0-9825-FC47916FE7C2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0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077890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phic 8">
            <a:extLst>
              <a:ext uri="{FF2B5EF4-FFF2-40B4-BE49-F238E27FC236}">
                <a16:creationId xmlns:a16="http://schemas.microsoft.com/office/drawing/2014/main" id="{6CC81EFB-5710-45DB-B43C-B70C3AC8713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858646" y="1610591"/>
            <a:ext cx="7516812" cy="325789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7DB7DE6-7902-453A-9CD2-15B9E3FAF151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1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092623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ACD0E3C-FB27-4E34-9D6A-07907C5945AA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2 </a:t>
            </a:r>
            <a:endParaRPr lang="en-US" dirty="0"/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78D87E63-5915-4E1E-B9CE-94F38564CC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588747" y="0"/>
            <a:ext cx="301450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87943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A365BB-12D1-4897-8D8A-7BA6CD028F8D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3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F9036516-FBB7-4AEE-A297-0F1B214B20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507650" y="0"/>
            <a:ext cx="317669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2938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DED3C02-D818-49AA-AC22-3E5339DD73D4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1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B42A9A88-A8B2-4026-88A1-4F61762272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0" y="1355651"/>
            <a:ext cx="12192000" cy="4146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72857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1693DF6-2BD1-46BD-9B66-388949E99DA9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2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65FAD769-0610-4F14-9687-44D48FDC35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647406" y="162902"/>
            <a:ext cx="6920390" cy="66515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21040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A6EAD8-8C48-4E2E-AE0B-3C18169134E4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3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9648A896-A271-46A8-80AD-88683A6B40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449995" y="0"/>
            <a:ext cx="329200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96784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F1BED24-598F-46DE-AF9E-B80DB02227CC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4 </a:t>
            </a:r>
            <a:endParaRPr lang="en-US" dirty="0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B030C0CB-65D0-436E-AC86-B08CD83BF6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300287" y="1752600"/>
            <a:ext cx="7591425" cy="3352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80147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5EAFAB-AF52-447D-886D-82A58188AD25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5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21E6D8C9-9E45-488B-B574-C5A2F94A3F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990725" y="190500"/>
            <a:ext cx="8210550" cy="6477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2899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E9AA870-AB7B-4DAC-82C2-F85A2861022E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6</a:t>
            </a:r>
            <a:endParaRPr lang="en-US" dirty="0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411B8CB8-A09D-4AA2-83B7-FE1B3763BC4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880422" y="0"/>
            <a:ext cx="443115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21675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57AA05F-AFAA-4689-B8A4-1CEB64A87D1A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7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6187655C-0DBD-4212-8152-6890C51146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974783" y="628212"/>
            <a:ext cx="6217217" cy="5356371"/>
          </a:xfrm>
          <a:prstGeom prst="rect">
            <a:avLst/>
          </a:prstGeom>
        </p:spPr>
      </p:pic>
      <p:pic>
        <p:nvPicPr>
          <p:cNvPr id="8" name="Graphic 7">
            <a:extLst>
              <a:ext uri="{FF2B5EF4-FFF2-40B4-BE49-F238E27FC236}">
                <a16:creationId xmlns:a16="http://schemas.microsoft.com/office/drawing/2014/main" id="{185943DB-0170-4241-A5A3-FDD1F95CE1D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0" y="1756791"/>
            <a:ext cx="5984146" cy="3269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1287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6403746-7404-4143-9BC5-0330339421C4}"/>
              </a:ext>
            </a:extLst>
          </p:cNvPr>
          <p:cNvSpPr txBox="1"/>
          <p:nvPr/>
        </p:nvSpPr>
        <p:spPr>
          <a:xfrm>
            <a:off x="-1656" y="0"/>
            <a:ext cx="60976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8 </a:t>
            </a:r>
            <a:endParaRPr lang="en-US" dirty="0"/>
          </a:p>
        </p:txBody>
      </p:sp>
      <p:pic>
        <p:nvPicPr>
          <p:cNvPr id="5" name="Graphic 4">
            <a:extLst>
              <a:ext uri="{FF2B5EF4-FFF2-40B4-BE49-F238E27FC236}">
                <a16:creationId xmlns:a16="http://schemas.microsoft.com/office/drawing/2014/main" id="{E76843E8-20BE-4694-A4DE-F40158FFED4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596023" y="0"/>
            <a:ext cx="499995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924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8</TotalTime>
  <Words>1655</Words>
  <Application>Microsoft Office PowerPoint</Application>
  <PresentationFormat>Widescreen</PresentationFormat>
  <Paragraphs>57</Paragraphs>
  <Slides>14</Slides>
  <Notes>1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mila</dc:creator>
  <cp:lastModifiedBy>Camila</cp:lastModifiedBy>
  <cp:revision>39</cp:revision>
  <dcterms:created xsi:type="dcterms:W3CDTF">2021-11-08T17:54:28Z</dcterms:created>
  <dcterms:modified xsi:type="dcterms:W3CDTF">2022-02-12T16:31:05Z</dcterms:modified>
</cp:coreProperties>
</file>